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A43B-1AE9-4B2C-9F53-7D0AD4FAD63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16E6F-00DA-4A7B-B612-3A1DD6C0C4B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99346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A43B-1AE9-4B2C-9F53-7D0AD4FAD63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16E6F-00DA-4A7B-B612-3A1DD6C0C4B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72759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A43B-1AE9-4B2C-9F53-7D0AD4FAD63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16E6F-00DA-4A7B-B612-3A1DD6C0C4B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15326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A43B-1AE9-4B2C-9F53-7D0AD4FAD63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16E6F-00DA-4A7B-B612-3A1DD6C0C4B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41635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A43B-1AE9-4B2C-9F53-7D0AD4FAD63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16E6F-00DA-4A7B-B612-3A1DD6C0C4B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49176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A43B-1AE9-4B2C-9F53-7D0AD4FAD63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16E6F-00DA-4A7B-B612-3A1DD6C0C4B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156487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A43B-1AE9-4B2C-9F53-7D0AD4FAD63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16E6F-00DA-4A7B-B612-3A1DD6C0C4B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69046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A43B-1AE9-4B2C-9F53-7D0AD4FAD63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16E6F-00DA-4A7B-B612-3A1DD6C0C4B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82446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A43B-1AE9-4B2C-9F53-7D0AD4FAD63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16E6F-00DA-4A7B-B612-3A1DD6C0C4B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02943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A43B-1AE9-4B2C-9F53-7D0AD4FAD63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16E6F-00DA-4A7B-B612-3A1DD6C0C4B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56747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A43B-1AE9-4B2C-9F53-7D0AD4FAD63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16E6F-00DA-4A7B-B612-3A1DD6C0C4B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336533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CAA43B-1AE9-4B2C-9F53-7D0AD4FAD63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D16E6F-00DA-4A7B-B612-3A1DD6C0C4B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22032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7D4E80E6-B333-47DA-A3C2-DA7C975C88C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92815" y="1307805"/>
            <a:ext cx="8772066" cy="42596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857518D-3553-4E57-AFA9-B5EEFEFD7911}"/>
              </a:ext>
            </a:extLst>
          </p:cNvPr>
          <p:cNvSpPr txBox="1"/>
          <p:nvPr/>
        </p:nvSpPr>
        <p:spPr>
          <a:xfrm>
            <a:off x="5835178" y="2294895"/>
            <a:ext cx="16498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Catechin pure standar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A38F329-0F57-4DF7-AFE0-F1088803EBE6}"/>
              </a:ext>
            </a:extLst>
          </p:cNvPr>
          <p:cNvSpPr txBox="1"/>
          <p:nvPr/>
        </p:nvSpPr>
        <p:spPr>
          <a:xfrm>
            <a:off x="5348468" y="3931159"/>
            <a:ext cx="2895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100" dirty="0" err="1">
                <a:latin typeface="Arial" panose="020B0604020202020204" pitchFamily="34" charset="0"/>
                <a:cs typeface="Arial" panose="020B0604020202020204" pitchFamily="34" charset="0"/>
              </a:rPr>
              <a:t>Marula</a:t>
            </a:r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 stem ethanol extrac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BD1B336-122F-4353-8FF7-97A43CA56993}"/>
              </a:ext>
            </a:extLst>
          </p:cNvPr>
          <p:cNvSpPr txBox="1"/>
          <p:nvPr/>
        </p:nvSpPr>
        <p:spPr>
          <a:xfrm>
            <a:off x="2057400" y="5867401"/>
            <a:ext cx="704551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Additional file 6</a:t>
            </a:r>
          </a:p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Negative mode BPI chromatogram of catechin pure standard overlaid with that of </a:t>
            </a:r>
            <a:r>
              <a:rPr lang="en-ZA" sz="1100" dirty="0" err="1">
                <a:latin typeface="Arial" panose="020B0604020202020204" pitchFamily="34" charset="0"/>
                <a:cs typeface="Arial" panose="020B0604020202020204" pitchFamily="34" charset="0"/>
              </a:rPr>
              <a:t>Marula</a:t>
            </a:r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 stem ethanol extract </a:t>
            </a:r>
          </a:p>
        </p:txBody>
      </p:sp>
    </p:spTree>
    <p:extLst>
      <p:ext uri="{BB962C8B-B14F-4D97-AF65-F5344CB8AC3E}">
        <p14:creationId xmlns:p14="http://schemas.microsoft.com/office/powerpoint/2010/main" val="2646504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6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no</dc:creator>
  <cp:lastModifiedBy>Tino</cp:lastModifiedBy>
  <cp:revision>4</cp:revision>
  <cp:lastPrinted>2017-04-27T08:09:52Z</cp:lastPrinted>
  <dcterms:created xsi:type="dcterms:W3CDTF">2017-04-22T13:13:06Z</dcterms:created>
  <dcterms:modified xsi:type="dcterms:W3CDTF">2017-09-21T09:24:38Z</dcterms:modified>
</cp:coreProperties>
</file>